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0/07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0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407704"/>
            <a:ext cx="7208101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Luk et al (2025) Diabetologia DOI 10.1007/s00125-025-06482-8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504" y="260648"/>
            <a:ext cx="90730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Schematic showing the contributions of biological and clinical factors and social determinants of health to heterogeneity in the development of diabetes-related complications across countries, regions and population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75948E6-569B-1509-6FF4-E7D73E7883D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4552" y="1522304"/>
            <a:ext cx="7834896" cy="4066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28080" y="5756483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r>
              <a:rPr lang="en-GB" dirty="0"/>
              <a:t>Luk et al (2025) </a:t>
            </a:r>
            <a:r>
              <a:rPr lang="en-GB" dirty="0" err="1"/>
              <a:t>Diabetologia</a:t>
            </a:r>
            <a:r>
              <a:rPr lang="en-GB" dirty="0"/>
              <a:t> DOI 10.1007/s00125-025-06482-8</a:t>
            </a:r>
            <a:endParaRPr lang="en-GB" dirty="0">
              <a:solidFill>
                <a:srgbClr val="FF0000"/>
              </a:solidFill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7504" y="272842"/>
            <a:ext cx="3024336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Incidence rates (per 1000 person-years) of major adverse cardiovascular</a:t>
            </a:r>
          </a:p>
          <a:p>
            <a:r>
              <a:rPr lang="en-US" b="1" dirty="0"/>
              <a:t>events (a), myocardial infarction (b), stroke (c), peripheral artery disease (d) and end-stage kidney disease (e) in individuals with type 2 diabetes across different regions and countries from studies published between 2015 and 2025</a:t>
            </a:r>
            <a:endParaRPr lang="en-GB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048762E-855C-DA48-A0A4-55BD6C185C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31840" y="404664"/>
            <a:ext cx="5767515" cy="5298198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4</Words>
  <Application>Microsoft Office PowerPoint</Application>
  <PresentationFormat>On-screen Show (4:3)</PresentationFormat>
  <Paragraphs>11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51</cp:revision>
  <dcterms:created xsi:type="dcterms:W3CDTF">2016-06-15T12:53:43Z</dcterms:created>
  <dcterms:modified xsi:type="dcterms:W3CDTF">2025-07-10T07:14:04Z</dcterms:modified>
</cp:coreProperties>
</file>